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K$133</c:f>
              <c:strCache>
                <c:ptCount val="1"/>
              </c:strCache>
            </c:strRef>
          </c:tx>
          <c:spPr>
            <a:solidFill>
              <a:srgbClr val="4472C4"/>
            </a:solidFill>
            <a:ln w="25400">
              <a:noFill/>
            </a:ln>
          </c:spPr>
          <c:invertIfNegative val="0"/>
          <c:cat>
            <c:strRef>
              <c:f>Sheet1!$J$134:$J$170</c:f>
              <c:strCache>
                <c:ptCount val="37"/>
                <c:pt idx="0">
                  <c:v>t3576-CC522</c:v>
                </c:pt>
                <c:pt idx="1">
                  <c:v>t10018-CC522</c:v>
                </c:pt>
                <c:pt idx="2">
                  <c:v>t18949*-CC97</c:v>
                </c:pt>
                <c:pt idx="3">
                  <c:v>t9268-CC522</c:v>
                </c:pt>
                <c:pt idx="4">
                  <c:v>t18947*-CC133</c:v>
                </c:pt>
                <c:pt idx="5">
                  <c:v>t127-CC1</c:v>
                </c:pt>
                <c:pt idx="6">
                  <c:v>t355-CC152</c:v>
                </c:pt>
                <c:pt idx="7">
                  <c:v>t8948-CC133</c:v>
                </c:pt>
                <c:pt idx="8">
                  <c:v>t18946*-CC522</c:v>
                </c:pt>
                <c:pt idx="9">
                  <c:v>t18948*-CC133</c:v>
                </c:pt>
                <c:pt idx="10">
                  <c:v>t18950*-CC30</c:v>
                </c:pt>
                <c:pt idx="11">
                  <c:v>t537-CC8</c:v>
                </c:pt>
                <c:pt idx="12">
                  <c:v>t19031*-CC522</c:v>
                </c:pt>
                <c:pt idx="13">
                  <c:v>t008-CC8</c:v>
                </c:pt>
                <c:pt idx="14">
                  <c:v>t111-CC5</c:v>
                </c:pt>
                <c:pt idx="15">
                  <c:v>t189-CC1</c:v>
                </c:pt>
                <c:pt idx="16">
                  <c:v>t314-CC121</c:v>
                </c:pt>
                <c:pt idx="17">
                  <c:v>t318-CC30</c:v>
                </c:pt>
                <c:pt idx="18">
                  <c:v>t359-CC97</c:v>
                </c:pt>
                <c:pt idx="19">
                  <c:v>t538-CC522</c:v>
                </c:pt>
                <c:pt idx="20">
                  <c:v>t701-CC5</c:v>
                </c:pt>
                <c:pt idx="21">
                  <c:v>t777-CC5</c:v>
                </c:pt>
                <c:pt idx="22">
                  <c:v>t861-CC45</c:v>
                </c:pt>
                <c:pt idx="23">
                  <c:v>t903-CC97</c:v>
                </c:pt>
                <c:pt idx="24">
                  <c:v>t3585-CC133</c:v>
                </c:pt>
                <c:pt idx="25">
                  <c:v>t4690-CC152</c:v>
                </c:pt>
                <c:pt idx="26">
                  <c:v>t5126-CC15</c:v>
                </c:pt>
                <c:pt idx="27">
                  <c:v>t8821-CC152</c:v>
                </c:pt>
                <c:pt idx="28">
                  <c:v>t11108-CC8</c:v>
                </c:pt>
                <c:pt idx="29">
                  <c:v>t13260-CC522</c:v>
                </c:pt>
                <c:pt idx="30">
                  <c:v>t19037*-CC522</c:v>
                </c:pt>
                <c:pt idx="31">
                  <c:v>t19063*-ST6096</c:v>
                </c:pt>
                <c:pt idx="32">
                  <c:v>t19064*-ST6082</c:v>
                </c:pt>
                <c:pt idx="33">
                  <c:v>t19065*-CC522</c:v>
                </c:pt>
                <c:pt idx="34">
                  <c:v>t19066*-CC522</c:v>
                </c:pt>
                <c:pt idx="35">
                  <c:v>t19067*-CC133</c:v>
                </c:pt>
                <c:pt idx="36">
                  <c:v>t19068*-CC15</c:v>
                </c:pt>
              </c:strCache>
            </c:strRef>
          </c:cat>
          <c:val>
            <c:numRef>
              <c:f>Sheet1!$K$134:$K$170</c:f>
              <c:numCache>
                <c:formatCode>General</c:formatCode>
                <c:ptCount val="37"/>
              </c:numCache>
            </c:numRef>
          </c:val>
        </c:ser>
        <c:ser>
          <c:idx val="1"/>
          <c:order val="1"/>
          <c:tx>
            <c:strRef>
              <c:f>Sheet1!$L$133</c:f>
              <c:strCache>
                <c:ptCount val="1"/>
                <c:pt idx="0">
                  <c:v>MSSA</c:v>
                </c:pt>
              </c:strCache>
            </c:strRef>
          </c:tx>
          <c:spPr>
            <a:solidFill>
              <a:srgbClr val="0070C0"/>
            </a:solidFill>
            <a:ln w="25400">
              <a:noFill/>
            </a:ln>
          </c:spPr>
          <c:invertIfNegative val="0"/>
          <c:cat>
            <c:strRef>
              <c:f>Sheet1!$J$134:$J$170</c:f>
              <c:strCache>
                <c:ptCount val="37"/>
                <c:pt idx="0">
                  <c:v>t3576-CC522</c:v>
                </c:pt>
                <c:pt idx="1">
                  <c:v>t10018-CC522</c:v>
                </c:pt>
                <c:pt idx="2">
                  <c:v>t18949*-CC97</c:v>
                </c:pt>
                <c:pt idx="3">
                  <c:v>t9268-CC522</c:v>
                </c:pt>
                <c:pt idx="4">
                  <c:v>t18947*-CC133</c:v>
                </c:pt>
                <c:pt idx="5">
                  <c:v>t127-CC1</c:v>
                </c:pt>
                <c:pt idx="6">
                  <c:v>t355-CC152</c:v>
                </c:pt>
                <c:pt idx="7">
                  <c:v>t8948-CC133</c:v>
                </c:pt>
                <c:pt idx="8">
                  <c:v>t18946*-CC522</c:v>
                </c:pt>
                <c:pt idx="9">
                  <c:v>t18948*-CC133</c:v>
                </c:pt>
                <c:pt idx="10">
                  <c:v>t18950*-CC30</c:v>
                </c:pt>
                <c:pt idx="11">
                  <c:v>t537-CC8</c:v>
                </c:pt>
                <c:pt idx="12">
                  <c:v>t19031*-CC522</c:v>
                </c:pt>
                <c:pt idx="13">
                  <c:v>t008-CC8</c:v>
                </c:pt>
                <c:pt idx="14">
                  <c:v>t111-CC5</c:v>
                </c:pt>
                <c:pt idx="15">
                  <c:v>t189-CC1</c:v>
                </c:pt>
                <c:pt idx="16">
                  <c:v>t314-CC121</c:v>
                </c:pt>
                <c:pt idx="17">
                  <c:v>t318-CC30</c:v>
                </c:pt>
                <c:pt idx="18">
                  <c:v>t359-CC97</c:v>
                </c:pt>
                <c:pt idx="19">
                  <c:v>t538-CC522</c:v>
                </c:pt>
                <c:pt idx="20">
                  <c:v>t701-CC5</c:v>
                </c:pt>
                <c:pt idx="21">
                  <c:v>t777-CC5</c:v>
                </c:pt>
                <c:pt idx="22">
                  <c:v>t861-CC45</c:v>
                </c:pt>
                <c:pt idx="23">
                  <c:v>t903-CC97</c:v>
                </c:pt>
                <c:pt idx="24">
                  <c:v>t3585-CC133</c:v>
                </c:pt>
                <c:pt idx="25">
                  <c:v>t4690-CC152</c:v>
                </c:pt>
                <c:pt idx="26">
                  <c:v>t5126-CC15</c:v>
                </c:pt>
                <c:pt idx="27">
                  <c:v>t8821-CC152</c:v>
                </c:pt>
                <c:pt idx="28">
                  <c:v>t11108-CC8</c:v>
                </c:pt>
                <c:pt idx="29">
                  <c:v>t13260-CC522</c:v>
                </c:pt>
                <c:pt idx="30">
                  <c:v>t19037*-CC522</c:v>
                </c:pt>
                <c:pt idx="31">
                  <c:v>t19063*-ST6096</c:v>
                </c:pt>
                <c:pt idx="32">
                  <c:v>t19064*-ST6082</c:v>
                </c:pt>
                <c:pt idx="33">
                  <c:v>t19065*-CC522</c:v>
                </c:pt>
                <c:pt idx="34">
                  <c:v>t19066*-CC522</c:v>
                </c:pt>
                <c:pt idx="35">
                  <c:v>t19067*-CC133</c:v>
                </c:pt>
                <c:pt idx="36">
                  <c:v>t19068*-CC15</c:v>
                </c:pt>
              </c:strCache>
            </c:strRef>
          </c:cat>
          <c:val>
            <c:numRef>
              <c:f>Sheet1!$L$134:$L$170</c:f>
              <c:numCache>
                <c:formatCode>General</c:formatCode>
                <c:ptCount val="37"/>
                <c:pt idx="0">
                  <c:v>15</c:v>
                </c:pt>
                <c:pt idx="1">
                  <c:v>12</c:v>
                </c:pt>
                <c:pt idx="2">
                  <c:v>7</c:v>
                </c:pt>
                <c:pt idx="3">
                  <c:v>6</c:v>
                </c:pt>
                <c:pt idx="4">
                  <c:v>4</c:v>
                </c:pt>
                <c:pt idx="5">
                  <c:v>1</c:v>
                </c:pt>
                <c:pt idx="6">
                  <c:v>3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2</c:v>
                </c:pt>
                <c:pt idx="12">
                  <c:v>2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0</c:v>
                </c:pt>
                <c:pt idx="26">
                  <c:v>1</c:v>
                </c:pt>
                <c:pt idx="27">
                  <c:v>0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</c:numCache>
            </c:numRef>
          </c:val>
        </c:ser>
        <c:ser>
          <c:idx val="2"/>
          <c:order val="2"/>
          <c:tx>
            <c:strRef>
              <c:f>Sheet1!$M$133</c:f>
              <c:strCache>
                <c:ptCount val="1"/>
                <c:pt idx="0">
                  <c:v>MRSA</c:v>
                </c:pt>
              </c:strCache>
            </c:strRef>
          </c:tx>
          <c:spPr>
            <a:solidFill>
              <a:srgbClr val="FF0000"/>
            </a:solidFill>
            <a:ln w="25400">
              <a:noFill/>
            </a:ln>
          </c:spPr>
          <c:invertIfNegative val="0"/>
          <c:cat>
            <c:strRef>
              <c:f>Sheet1!$J$134:$J$170</c:f>
              <c:strCache>
                <c:ptCount val="37"/>
                <c:pt idx="0">
                  <c:v>t3576-CC522</c:v>
                </c:pt>
                <c:pt idx="1">
                  <c:v>t10018-CC522</c:v>
                </c:pt>
                <c:pt idx="2">
                  <c:v>t18949*-CC97</c:v>
                </c:pt>
                <c:pt idx="3">
                  <c:v>t9268-CC522</c:v>
                </c:pt>
                <c:pt idx="4">
                  <c:v>t18947*-CC133</c:v>
                </c:pt>
                <c:pt idx="5">
                  <c:v>t127-CC1</c:v>
                </c:pt>
                <c:pt idx="6">
                  <c:v>t355-CC152</c:v>
                </c:pt>
                <c:pt idx="7">
                  <c:v>t8948-CC133</c:v>
                </c:pt>
                <c:pt idx="8">
                  <c:v>t18946*-CC522</c:v>
                </c:pt>
                <c:pt idx="9">
                  <c:v>t18948*-CC133</c:v>
                </c:pt>
                <c:pt idx="10">
                  <c:v>t18950*-CC30</c:v>
                </c:pt>
                <c:pt idx="11">
                  <c:v>t537-CC8</c:v>
                </c:pt>
                <c:pt idx="12">
                  <c:v>t19031*-CC522</c:v>
                </c:pt>
                <c:pt idx="13">
                  <c:v>t008-CC8</c:v>
                </c:pt>
                <c:pt idx="14">
                  <c:v>t111-CC5</c:v>
                </c:pt>
                <c:pt idx="15">
                  <c:v>t189-CC1</c:v>
                </c:pt>
                <c:pt idx="16">
                  <c:v>t314-CC121</c:v>
                </c:pt>
                <c:pt idx="17">
                  <c:v>t318-CC30</c:v>
                </c:pt>
                <c:pt idx="18">
                  <c:v>t359-CC97</c:v>
                </c:pt>
                <c:pt idx="19">
                  <c:v>t538-CC522</c:v>
                </c:pt>
                <c:pt idx="20">
                  <c:v>t701-CC5</c:v>
                </c:pt>
                <c:pt idx="21">
                  <c:v>t777-CC5</c:v>
                </c:pt>
                <c:pt idx="22">
                  <c:v>t861-CC45</c:v>
                </c:pt>
                <c:pt idx="23">
                  <c:v>t903-CC97</c:v>
                </c:pt>
                <c:pt idx="24">
                  <c:v>t3585-CC133</c:v>
                </c:pt>
                <c:pt idx="25">
                  <c:v>t4690-CC152</c:v>
                </c:pt>
                <c:pt idx="26">
                  <c:v>t5126-CC15</c:v>
                </c:pt>
                <c:pt idx="27">
                  <c:v>t8821-CC152</c:v>
                </c:pt>
                <c:pt idx="28">
                  <c:v>t11108-CC8</c:v>
                </c:pt>
                <c:pt idx="29">
                  <c:v>t13260-CC522</c:v>
                </c:pt>
                <c:pt idx="30">
                  <c:v>t19037*-CC522</c:v>
                </c:pt>
                <c:pt idx="31">
                  <c:v>t19063*-ST6096</c:v>
                </c:pt>
                <c:pt idx="32">
                  <c:v>t19064*-ST6082</c:v>
                </c:pt>
                <c:pt idx="33">
                  <c:v>t19065*-CC522</c:v>
                </c:pt>
                <c:pt idx="34">
                  <c:v>t19066*-CC522</c:v>
                </c:pt>
                <c:pt idx="35">
                  <c:v>t19067*-CC133</c:v>
                </c:pt>
                <c:pt idx="36">
                  <c:v>t19068*-CC15</c:v>
                </c:pt>
              </c:strCache>
            </c:strRef>
          </c:cat>
          <c:val>
            <c:numRef>
              <c:f>Sheet1!$M$134:$M$170</c:f>
              <c:numCache>
                <c:formatCode>General</c:formatCode>
                <c:ptCount val="3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1</c:v>
                </c:pt>
                <c:pt idx="26">
                  <c:v>0</c:v>
                </c:pt>
                <c:pt idx="27">
                  <c:v>1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1"/>
        <c:overlap val="100"/>
        <c:axId val="296586472"/>
        <c:axId val="296588040"/>
      </c:barChart>
      <c:catAx>
        <c:axId val="296586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96588040"/>
        <c:crosses val="autoZero"/>
        <c:auto val="1"/>
        <c:lblAlgn val="ctr"/>
        <c:lblOffset val="100"/>
        <c:noMultiLvlLbl val="0"/>
      </c:catAx>
      <c:valAx>
        <c:axId val="2965880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Number</a:t>
                </a:r>
                <a:r>
                  <a:rPr lang="en-US" sz="12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of isolates</a:t>
                </a:r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2838469900680605E-2"/>
              <c:y val="0.27779019319681109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6586472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egendEntry>
        <c:idx val="0"/>
        <c:delete val="1"/>
      </c:legendEntry>
      <c:layout/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923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6215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0727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9191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279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795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139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1473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7704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975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42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4E46B-C3F8-4331-982A-841195E13C5D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9DCA7-BD26-47E0-A97B-07AF65895F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7365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122218" y="157941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993543"/>
              </p:ext>
            </p:extLst>
          </p:nvPr>
        </p:nvGraphicFramePr>
        <p:xfrm>
          <a:off x="708660" y="674371"/>
          <a:ext cx="10881359" cy="5257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/>
          <p:cNvSpPr/>
          <p:nvPr/>
        </p:nvSpPr>
        <p:spPr>
          <a:xfrm>
            <a:off x="841663" y="10391"/>
            <a:ext cx="10910455" cy="5604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S3 Distribution of 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a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C of 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olates from the WAD goat in Nigeria</a:t>
            </a:r>
            <a:endParaRPr lang="en-US" sz="16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24690" y="5954267"/>
            <a:ext cx="1185602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gend: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ltilocus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quence typing (MLST) of the isolates was determined from WGS assembled files processed through the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g)MLST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e. The sequence types (STs) were subsequently related to clonal complexes (CCs) using the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BURST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gorithm. *new </a:t>
            </a:r>
            <a:r>
              <a:rPr lang="en-US" sz="1600" i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a</a:t>
            </a:r>
            <a:r>
              <a:rPr lang="en-US" sz="16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ypes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489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2</TotalTime>
  <Words>7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GGC OMUARAN</dc:creator>
  <cp:lastModifiedBy>Adebayo Shittu</cp:lastModifiedBy>
  <cp:revision>39</cp:revision>
  <dcterms:created xsi:type="dcterms:W3CDTF">2021-01-12T15:20:23Z</dcterms:created>
  <dcterms:modified xsi:type="dcterms:W3CDTF">2021-08-15T22:47:10Z</dcterms:modified>
</cp:coreProperties>
</file>